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57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916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" y="1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2B432A-E381-47C5-BC21-59E5594AA1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F28ADA-DD19-4A36-A163-6222BC5E61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292B00-39E2-4701-85D1-C810F750F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8C6B06-10F2-482B-B6C5-3BAC7E59B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8D19F8-E113-432D-952C-5914B1F49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856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C3FA6C-1578-45C6-867D-EA8F24F18D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4477AC-D81E-403C-A9EE-FC17128C06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FD3D8D-3B81-4EF7-86C9-6CC497306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7A79C-6FE3-4CD2-B546-D9D5DB6D6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4470CB-295C-455D-A596-B33D9053C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895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D757462-3587-43FF-AF43-4A7436CB2B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9A22EB-5F2D-4716-B0A3-EC4F614E85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29D2EE-6DD9-4AAD-B221-25E148B87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28EC31-2D8F-4D84-B779-5D0DE8885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AF46BF-DC11-4DE5-A082-AE3D3F4DC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445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396BE9-88A4-47A0-919E-585DFFD7CA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191760-CE0C-4FDA-A57F-A278BBDFF0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2E2AEB-1187-43D7-9340-03CE09736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9DDFA6-075B-476D-BA04-A9669D59EB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885F2A-57DB-4217-AC68-9F881FACE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983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B1539-06F7-4A92-AE5E-EC188E85FF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FE355F-B1A6-4CF6-AC11-575D9D53CA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1E8E5C-119E-4EE9-932A-CAB10FCF9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3386C-B341-4833-96B6-7E7BFC3D4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63EA3E-18E3-44C1-A96B-D1EFA9191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365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237871-F103-4E75-8005-05CC07C93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24DB54-0795-478C-B069-6EEFEE25DE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F74EEC-447A-4A12-9123-4BD6D4CC9D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1C613F-C2CC-4C13-A05A-DFF52A374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C22147-E340-4F3E-A35F-B19DA950E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0BEF74-91AC-4D37-9866-F7EDC3946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006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9D345-00A2-4089-946C-21C468233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DCF660-3ED3-40D0-B737-10F59F07EA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C1CD28-0967-47C8-8B59-B673B3501C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A7D523-C3C1-4CDA-AB4F-27693A5D72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49EEB9-7390-419B-A760-C20D7A2146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13F934E-69AC-49D6-A393-8E32A189E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85966C6-D3A3-421B-916D-5547E2A3C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61AFCC3-F76D-4CAF-B08B-A8F17936D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182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6BEF6D-043B-48DF-9EE4-2912746A3E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14E230A-E5F6-42B5-BEBC-C1FC47F54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E42651-9A78-4AA3-9B99-3261230C6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62DFD8-120E-4434-A99C-49B7134769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13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8E83FF-A20D-4A3F-AE45-F08CBADD9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BB612C-50E0-4582-AF7D-F4FFDF99A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FA5CD2-F429-4433-88CA-5461CD6CB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689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B2EE3-FDEB-4E16-BBAE-33BDD73B4B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F8E869-10AA-47D5-ADE1-022BED1D1E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425128-0A36-4FC2-84F8-52EF607567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0C84E2-AE8D-401D-B03D-F30D34557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F9A791-F8AB-4E45-82FB-3791958B9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A6CA73-54BF-42DB-B3FA-C56DCEBDA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998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FF9E92-31BB-4707-8F4E-F640958707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E82EED-33CD-48C0-974B-1B96BB7C92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2F6F1A-91A0-4CF2-82EE-D996CA000E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14670B-7761-4A3F-99DD-D47AB1D16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DA6786-FED1-4031-BBE0-0D72FCA70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739E88-CCB4-438B-937D-18172CE3D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429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2EF959-3585-4B87-AB76-993EDAD60D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52A940-18F7-410E-8A11-357558A2DD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CF52B7-990A-42D3-ADB3-357C9C9652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9B945-08B6-495F-B0F3-92BB7700574E}" type="datetimeFigureOut">
              <a:rPr lang="en-US" smtClean="0"/>
              <a:t>11/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D18DCD-62D2-4929-BB77-832925386F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3E8262-5BFF-485C-923B-B492971BB0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91633-5BA0-49E7-B49C-8BF54A7268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26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768B13E-8E16-42B8-BFAC-1053D1809B85}"/>
              </a:ext>
            </a:extLst>
          </p:cNvPr>
          <p:cNvSpPr txBox="1"/>
          <p:nvPr/>
        </p:nvSpPr>
        <p:spPr>
          <a:xfrm>
            <a:off x="776654" y="474785"/>
            <a:ext cx="10638692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ure 1</a:t>
            </a:r>
            <a:r>
              <a:rPr lang="en-US" dirty="0"/>
              <a:t>. Individual response of all 8 animals to OSS in each slice and stimulation direction. Individual activation maps (</a:t>
            </a:r>
            <a:r>
              <a:rPr lang="en-US" dirty="0" err="1"/>
              <a:t>p</a:t>
            </a:r>
            <a:r>
              <a:rPr lang="en-US" baseline="-25000" dirty="0" err="1"/>
              <a:t>FWE</a:t>
            </a:r>
            <a:r>
              <a:rPr lang="en-US" dirty="0"/>
              <a:t> &lt; 10</a:t>
            </a:r>
            <a:r>
              <a:rPr lang="en-US" baseline="30000" dirty="0"/>
              <a:t>-5</a:t>
            </a:r>
            <a:r>
              <a:rPr lang="en-US" dirty="0"/>
              <a:t>) are overlaid over anatomical T2-weighted images. Although fair data variability is seen, multiple brain areas display orientation dependence throughout the brain. 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ACC = anterior cingulate cortex, AMG = amygdala: co = cortical nucleus, </a:t>
            </a:r>
            <a:r>
              <a:rPr lang="en-US" dirty="0" err="1"/>
              <a:t>pl</a:t>
            </a:r>
            <a:r>
              <a:rPr lang="en-US" dirty="0"/>
              <a:t> = posterior lateral n.,  la = lateral n., </a:t>
            </a:r>
            <a:r>
              <a:rPr lang="en-US" dirty="0" err="1"/>
              <a:t>bm</a:t>
            </a:r>
            <a:r>
              <a:rPr lang="en-US" dirty="0"/>
              <a:t>/</a:t>
            </a:r>
            <a:r>
              <a:rPr lang="en-US" dirty="0" err="1"/>
              <a:t>bl</a:t>
            </a:r>
            <a:r>
              <a:rPr lang="en-US" dirty="0"/>
              <a:t> = </a:t>
            </a:r>
            <a:r>
              <a:rPr lang="en-US" dirty="0" err="1"/>
              <a:t>basomedial</a:t>
            </a:r>
            <a:r>
              <a:rPr lang="en-US" dirty="0"/>
              <a:t>/basolateral n., </a:t>
            </a:r>
            <a:r>
              <a:rPr lang="en-US" dirty="0" err="1"/>
              <a:t>ce</a:t>
            </a:r>
            <a:r>
              <a:rPr lang="en-US" dirty="0"/>
              <a:t> = central n., BST = bed nucleus of </a:t>
            </a:r>
            <a:r>
              <a:rPr lang="en-US" dirty="0" err="1"/>
              <a:t>stria</a:t>
            </a:r>
            <a:r>
              <a:rPr lang="en-US" dirty="0"/>
              <a:t> </a:t>
            </a:r>
            <a:r>
              <a:rPr lang="en-US" dirty="0" err="1"/>
              <a:t>terminalis</a:t>
            </a:r>
            <a:r>
              <a:rPr lang="en-US" dirty="0"/>
              <a:t>, </a:t>
            </a:r>
            <a:r>
              <a:rPr lang="en-US" dirty="0" err="1"/>
              <a:t>AOm</a:t>
            </a:r>
            <a:r>
              <a:rPr lang="en-US" dirty="0"/>
              <a:t> = anterior olfactory n. medial part, </a:t>
            </a:r>
            <a:r>
              <a:rPr lang="en-US" dirty="0" err="1"/>
              <a:t>CPm</a:t>
            </a:r>
            <a:r>
              <a:rPr lang="en-US" dirty="0"/>
              <a:t> = medial caudate putamen, DB = diagonal band of </a:t>
            </a:r>
            <a:r>
              <a:rPr lang="en-US" dirty="0" err="1"/>
              <a:t>Broca</a:t>
            </a:r>
            <a:r>
              <a:rPr lang="en-US" dirty="0"/>
              <a:t>, </a:t>
            </a:r>
            <a:r>
              <a:rPr lang="en-US" dirty="0" err="1"/>
              <a:t>ENTm</a:t>
            </a:r>
            <a:r>
              <a:rPr lang="en-US" dirty="0"/>
              <a:t> = medial entorhinal cortex, </a:t>
            </a:r>
            <a:r>
              <a:rPr lang="en-US" dirty="0" err="1"/>
              <a:t>HCv</a:t>
            </a:r>
            <a:r>
              <a:rPr lang="en-US" dirty="0"/>
              <a:t> = hippocampus ventral part, </a:t>
            </a:r>
            <a:r>
              <a:rPr lang="en-US" dirty="0" err="1"/>
              <a:t>HTla</a:t>
            </a:r>
            <a:r>
              <a:rPr lang="en-US" dirty="0"/>
              <a:t> = hypothalamus lateral part, IL = </a:t>
            </a:r>
            <a:r>
              <a:rPr lang="en-US" dirty="0" err="1"/>
              <a:t>infralimbic</a:t>
            </a:r>
            <a:r>
              <a:rPr lang="en-US" dirty="0"/>
              <a:t> cortex, </a:t>
            </a:r>
            <a:r>
              <a:rPr lang="en-US" dirty="0" err="1"/>
              <a:t>INSa</a:t>
            </a:r>
            <a:r>
              <a:rPr lang="en-US" dirty="0"/>
              <a:t> = anterior insular cortex, LS = lateral septum, M2 = supplementary motor cortex, </a:t>
            </a:r>
            <a:r>
              <a:rPr lang="en-US" dirty="0" err="1"/>
              <a:t>NAc</a:t>
            </a:r>
            <a:r>
              <a:rPr lang="en-US" dirty="0"/>
              <a:t> = nucleus </a:t>
            </a:r>
            <a:r>
              <a:rPr lang="en-US" dirty="0" err="1"/>
              <a:t>accumbens</a:t>
            </a:r>
            <a:r>
              <a:rPr lang="en-US" dirty="0"/>
              <a:t>, PIR = piriform cortex, PL = </a:t>
            </a:r>
            <a:r>
              <a:rPr lang="en-US" dirty="0" err="1"/>
              <a:t>prelimbic</a:t>
            </a:r>
            <a:r>
              <a:rPr lang="en-US" dirty="0"/>
              <a:t> cortex, SI = substantia </a:t>
            </a:r>
            <a:r>
              <a:rPr lang="en-US" dirty="0" err="1"/>
              <a:t>innominata</a:t>
            </a:r>
            <a:r>
              <a:rPr lang="en-US" dirty="0"/>
              <a:t>, THA = thalamus, VP = ventral pallidum.</a:t>
            </a:r>
          </a:p>
        </p:txBody>
      </p:sp>
    </p:spTree>
    <p:extLst>
      <p:ext uri="{BB962C8B-B14F-4D97-AF65-F5344CB8AC3E}">
        <p14:creationId xmlns:p14="http://schemas.microsoft.com/office/powerpoint/2010/main" val="14714018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2" y="329786"/>
            <a:ext cx="11470995" cy="6528209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1F0905E3-B0FC-462A-B9E0-CCF19AB077D7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43B1198-4E76-4B3C-A93A-81198BF4AE96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CEEC597-4405-4CA4-B62B-59C49D1025FB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8D9C74F-9C82-4016-A1B9-5361C1DFDF91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8E0DD64-E2E5-47A3-BF1F-996097578DCB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CB80E3A-1BBF-4DA0-9789-7120646FF60E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A07EFCE-4047-49CA-AA8E-955ADAA9305F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9D569F7-FE2C-4404-BB98-59C1CAC92E98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89DE96B-FEA1-4FE4-AFDF-1F6A84C90BAF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C626D11-EDD6-4428-85FA-6826D23823F1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4C9DBEB-2569-41AA-B6FD-4BA9C4A524D5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A07DDDD-11D8-4084-BD18-8A9934EA8E52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8099236-91E4-45E6-9AD7-3CC668C3BA20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00FD343-FBE8-43C1-B9CD-CD661D604705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08ECE50-10B5-4EBD-80A9-C5BA3103F1CA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9C17610-3D67-46EE-8779-A81A839C924C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B71A215-8660-494D-905E-051FEBB33534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98FF91-334F-4DEE-9A7A-3A2A6D1C7A9C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6405D1F-0071-4BFA-A47B-668C013D29C6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1458462-167A-4A24-A5AB-29739762F1B6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A1B6CF4-353D-4D8B-824A-00D9C8B365A3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97396DA7-8219-4B5C-A762-D13F04217D59}"/>
              </a:ext>
            </a:extLst>
          </p:cNvPr>
          <p:cNvCxnSpPr/>
          <p:nvPr/>
        </p:nvCxnSpPr>
        <p:spPr>
          <a:xfrm flipV="1">
            <a:off x="1151467" y="879357"/>
            <a:ext cx="102763" cy="85843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DC1FDDA2-C532-4312-904E-B7DB6EF917B5}"/>
              </a:ext>
            </a:extLst>
          </p:cNvPr>
          <p:cNvSpPr txBox="1"/>
          <p:nvPr/>
        </p:nvSpPr>
        <p:spPr>
          <a:xfrm>
            <a:off x="960560" y="909510"/>
            <a:ext cx="293670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13DC5429-B542-4F62-82FB-B7D003E88561}"/>
              </a:ext>
            </a:extLst>
          </p:cNvPr>
          <p:cNvCxnSpPr/>
          <p:nvPr/>
        </p:nvCxnSpPr>
        <p:spPr>
          <a:xfrm flipV="1">
            <a:off x="4038600" y="2527128"/>
            <a:ext cx="137659" cy="93305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2">
            <a:extLst>
              <a:ext uri="{FF2B5EF4-FFF2-40B4-BE49-F238E27FC236}">
                <a16:creationId xmlns:a16="http://schemas.microsoft.com/office/drawing/2014/main" id="{6767107C-26DB-4AD6-B552-B12DF236A3F7}"/>
              </a:ext>
            </a:extLst>
          </p:cNvPr>
          <p:cNvSpPr txBox="1"/>
          <p:nvPr/>
        </p:nvSpPr>
        <p:spPr>
          <a:xfrm>
            <a:off x="3515249" y="2548293"/>
            <a:ext cx="776119" cy="2308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Gbm</a:t>
            </a:r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A463A2BA-2F62-4AD3-AAE8-1CB2A4CCFE75}"/>
              </a:ext>
            </a:extLst>
          </p:cNvPr>
          <p:cNvCxnSpPr/>
          <p:nvPr/>
        </p:nvCxnSpPr>
        <p:spPr>
          <a:xfrm flipH="1" flipV="1">
            <a:off x="2394239" y="4150821"/>
            <a:ext cx="110738" cy="9525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2">
            <a:extLst>
              <a:ext uri="{FF2B5EF4-FFF2-40B4-BE49-F238E27FC236}">
                <a16:creationId xmlns:a16="http://schemas.microsoft.com/office/drawing/2014/main" id="{BBF20246-9A23-4794-8C12-F15B11545320}"/>
              </a:ext>
            </a:extLst>
          </p:cNvPr>
          <p:cNvSpPr txBox="1"/>
          <p:nvPr/>
        </p:nvSpPr>
        <p:spPr>
          <a:xfrm>
            <a:off x="2261095" y="4194925"/>
            <a:ext cx="37702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R</a:t>
            </a:r>
          </a:p>
        </p:txBody>
      </p:sp>
    </p:spTree>
    <p:extLst>
      <p:ext uri="{BB962C8B-B14F-4D97-AF65-F5344CB8AC3E}">
        <p14:creationId xmlns:p14="http://schemas.microsoft.com/office/powerpoint/2010/main" val="5293303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2" y="329786"/>
            <a:ext cx="11470995" cy="6528208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1E37A627-B4AF-4D66-8487-C2378CC15364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.0 mm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5BD1A41-A784-4A86-9AE3-A66DDBEDB5AB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129D5BF-764C-4BB5-83F1-C32CD7CEA28F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4FF628A-36CA-457F-A9E3-4B0C1FFD9FC4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6EE8CE0-D057-4C79-9E45-352E93BC39CF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D4B626E-F8C3-456D-920F-0F50945C0641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788135D-B309-47BF-BEB0-C7642C9A971E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F7682F1-B426-408A-8645-0355C4C95AFF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B93E202-7F62-43FE-BA4E-13BDF6D44571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A3637F2-6963-4FCB-BEC1-C341290339B0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271E5E8-6E83-4CAE-B2CF-BD7C20429C47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6B45866-8747-4F45-99D9-5D82A0230B09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64A55CE-9BFF-4B97-9FBD-7069D6B756CB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5E331B8-0D6B-412C-9D38-7B26C1051196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EE8C367-574C-4709-83BF-DD4F9952360B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0C690D6-963E-473D-87E9-7F3BF59EA4DD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EF69045-8F0D-4391-B15F-FF5F67706B94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82B40A7-5801-4F94-95EF-5D5FF2438599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65BBA93-69B1-4C9E-A8D3-837A3DCEA52B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175F036-B132-444D-86FA-92906A3BCD81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79733EB-0FD9-48A7-A434-C763BBBF8D07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D1917492-254F-4EA5-9DC6-20B9AAD24A52}"/>
              </a:ext>
            </a:extLst>
          </p:cNvPr>
          <p:cNvCxnSpPr/>
          <p:nvPr/>
        </p:nvCxnSpPr>
        <p:spPr>
          <a:xfrm flipH="1">
            <a:off x="5960997" y="2912533"/>
            <a:ext cx="188358" cy="197331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5EED34AF-2A51-403F-8C91-A892965BDECE}"/>
              </a:ext>
            </a:extLst>
          </p:cNvPr>
          <p:cNvSpPr txBox="1"/>
          <p:nvPr/>
        </p:nvSpPr>
        <p:spPr>
          <a:xfrm>
            <a:off x="6093045" y="2762651"/>
            <a:ext cx="332142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S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89BBDC86-B2AF-4F50-BC21-869951F14D62}"/>
              </a:ext>
            </a:extLst>
          </p:cNvPr>
          <p:cNvCxnSpPr/>
          <p:nvPr/>
        </p:nvCxnSpPr>
        <p:spPr>
          <a:xfrm flipH="1" flipV="1">
            <a:off x="6149355" y="4143502"/>
            <a:ext cx="115397" cy="7540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2">
            <a:extLst>
              <a:ext uri="{FF2B5EF4-FFF2-40B4-BE49-F238E27FC236}">
                <a16:creationId xmlns:a16="http://schemas.microsoft.com/office/drawing/2014/main" id="{735AD3FA-742E-4181-BBDE-9982A3BD9A81}"/>
              </a:ext>
            </a:extLst>
          </p:cNvPr>
          <p:cNvSpPr txBox="1"/>
          <p:nvPr/>
        </p:nvSpPr>
        <p:spPr>
          <a:xfrm>
            <a:off x="6093045" y="4191302"/>
            <a:ext cx="37702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R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A8B7CA00-74B8-470D-ABF5-7F018C1471CC}"/>
              </a:ext>
            </a:extLst>
          </p:cNvPr>
          <p:cNvCxnSpPr/>
          <p:nvPr/>
        </p:nvCxnSpPr>
        <p:spPr>
          <a:xfrm flipH="1" flipV="1">
            <a:off x="6963833" y="2511517"/>
            <a:ext cx="130913" cy="72473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2">
            <a:extLst>
              <a:ext uri="{FF2B5EF4-FFF2-40B4-BE49-F238E27FC236}">
                <a16:creationId xmlns:a16="http://schemas.microsoft.com/office/drawing/2014/main" id="{0BBB4D1C-A9EE-4761-B3C7-043A5DA39F35}"/>
              </a:ext>
            </a:extLst>
          </p:cNvPr>
          <p:cNvSpPr txBox="1"/>
          <p:nvPr/>
        </p:nvSpPr>
        <p:spPr>
          <a:xfrm>
            <a:off x="6963833" y="2524335"/>
            <a:ext cx="41549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ST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24198B09-A936-4A26-8DF5-B5EFB769C5AA}"/>
              </a:ext>
            </a:extLst>
          </p:cNvPr>
          <p:cNvCxnSpPr/>
          <p:nvPr/>
        </p:nvCxnSpPr>
        <p:spPr>
          <a:xfrm flipH="1" flipV="1">
            <a:off x="3220024" y="864855"/>
            <a:ext cx="147777" cy="154443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D88AD696-C63C-4EB7-872C-7304DA06E339}"/>
              </a:ext>
            </a:extLst>
          </p:cNvPr>
          <p:cNvCxnSpPr/>
          <p:nvPr/>
        </p:nvCxnSpPr>
        <p:spPr>
          <a:xfrm flipH="1" flipV="1">
            <a:off x="2152635" y="866714"/>
            <a:ext cx="215156" cy="115047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4FA2AC1F-5B50-4EA3-8EA9-5C5E10F15A46}"/>
              </a:ext>
            </a:extLst>
          </p:cNvPr>
          <p:cNvCxnSpPr/>
          <p:nvPr/>
        </p:nvCxnSpPr>
        <p:spPr>
          <a:xfrm>
            <a:off x="5783210" y="430107"/>
            <a:ext cx="98339" cy="101666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2">
            <a:extLst>
              <a:ext uri="{FF2B5EF4-FFF2-40B4-BE49-F238E27FC236}">
                <a16:creationId xmlns:a16="http://schemas.microsoft.com/office/drawing/2014/main" id="{F9727BD3-21AF-4BE7-9A78-7EA08DAC82D6}"/>
              </a:ext>
            </a:extLst>
          </p:cNvPr>
          <p:cNvSpPr txBox="1"/>
          <p:nvPr/>
        </p:nvSpPr>
        <p:spPr>
          <a:xfrm>
            <a:off x="5441111" y="289386"/>
            <a:ext cx="434734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C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8474818-725A-4BC0-8E7A-AD498882A47F}"/>
              </a:ext>
            </a:extLst>
          </p:cNvPr>
          <p:cNvCxnSpPr/>
          <p:nvPr/>
        </p:nvCxnSpPr>
        <p:spPr>
          <a:xfrm flipH="1">
            <a:off x="5003800" y="5299860"/>
            <a:ext cx="208111" cy="65722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">
            <a:extLst>
              <a:ext uri="{FF2B5EF4-FFF2-40B4-BE49-F238E27FC236}">
                <a16:creationId xmlns:a16="http://schemas.microsoft.com/office/drawing/2014/main" id="{7E0F5B29-FBF8-471D-A47E-FFF5A0365AD2}"/>
              </a:ext>
            </a:extLst>
          </p:cNvPr>
          <p:cNvSpPr txBox="1"/>
          <p:nvPr/>
        </p:nvSpPr>
        <p:spPr>
          <a:xfrm>
            <a:off x="5150850" y="5194137"/>
            <a:ext cx="34496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sp>
        <p:nvSpPr>
          <p:cNvPr id="49" name="TextBox 2">
            <a:extLst>
              <a:ext uri="{FF2B5EF4-FFF2-40B4-BE49-F238E27FC236}">
                <a16:creationId xmlns:a16="http://schemas.microsoft.com/office/drawing/2014/main" id="{0BBB4D1C-A9EE-4761-B3C7-043A5DA39F35}"/>
              </a:ext>
            </a:extLst>
          </p:cNvPr>
          <p:cNvSpPr txBox="1"/>
          <p:nvPr/>
        </p:nvSpPr>
        <p:spPr>
          <a:xfrm>
            <a:off x="2208937" y="906745"/>
            <a:ext cx="434734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la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2">
            <a:extLst>
              <a:ext uri="{FF2B5EF4-FFF2-40B4-BE49-F238E27FC236}">
                <a16:creationId xmlns:a16="http://schemas.microsoft.com/office/drawing/2014/main" id="{0BBB4D1C-A9EE-4761-B3C7-043A5DA39F35}"/>
              </a:ext>
            </a:extLst>
          </p:cNvPr>
          <p:cNvSpPr txBox="1"/>
          <p:nvPr/>
        </p:nvSpPr>
        <p:spPr>
          <a:xfrm>
            <a:off x="3254127" y="914022"/>
            <a:ext cx="344374" cy="2308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P</a:t>
            </a:r>
          </a:p>
        </p:txBody>
      </p:sp>
    </p:spTree>
    <p:extLst>
      <p:ext uri="{BB962C8B-B14F-4D97-AF65-F5344CB8AC3E}">
        <p14:creationId xmlns:p14="http://schemas.microsoft.com/office/powerpoint/2010/main" val="6002020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2" y="329786"/>
            <a:ext cx="11470994" cy="652820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D85F12D4-B68D-41E1-BDB4-72621F0F5E91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2BD7AA4-0BAA-4260-8C89-8C36ED7620BF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C32F016-6C92-4A99-B5C0-622CD1E15234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49E02B2-90CD-4A4D-AE9F-F807A8666412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A20B3D7-57A7-48C3-AE15-86D72BDD80B1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0358BC5-6DB8-42D6-A199-60BE21510D84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75F3CAE-8552-4DAE-B4A0-B5BC82E91B03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04BE0E4-E088-4AC1-86DC-B921F09E0E9B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3422326-463D-4655-8B60-BC745287AD8E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0ECDD31-43BF-4B00-8A2F-6C92A1848773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93A09F6-3A13-45E4-A8F7-6F355F6F552A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2FBC6E5-8356-4685-AA87-E455EE6FD2E2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2ED0D4B-831E-439F-B2AE-AD96F75EC063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C0B33A5-4134-4BF9-8DC2-F69034723D4F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14E888E-AFE5-4FCA-AC12-AD2BBF4218F7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50708DB-A59F-4436-A655-86E069A3F266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65F8D3D-5F29-4A6F-8ACC-9C20F32A68BD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CD84F14-B673-483C-BC5F-DA513F34E01C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5A354F0-E749-41A1-8454-4633ED31762A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FF6411A-B4B6-44AE-B311-7AEE371ED744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F07FC2C-C8F9-47EF-9601-A11F6E649724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BB602ED0-8D1A-48A5-B5C5-6304F3AA85F9}"/>
              </a:ext>
            </a:extLst>
          </p:cNvPr>
          <p:cNvCxnSpPr/>
          <p:nvPr/>
        </p:nvCxnSpPr>
        <p:spPr>
          <a:xfrm flipH="1">
            <a:off x="5038725" y="1267729"/>
            <a:ext cx="165239" cy="17255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274A5FCE-761C-47D1-9300-027EC249821D}"/>
              </a:ext>
            </a:extLst>
          </p:cNvPr>
          <p:cNvSpPr txBox="1"/>
          <p:nvPr/>
        </p:nvSpPr>
        <p:spPr>
          <a:xfrm>
            <a:off x="8847960" y="3551916"/>
            <a:ext cx="44755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m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E7DD30A6-E92F-4069-B34E-36A8BCC5B58A}"/>
              </a:ext>
            </a:extLst>
          </p:cNvPr>
          <p:cNvCxnSpPr/>
          <p:nvPr/>
        </p:nvCxnSpPr>
        <p:spPr>
          <a:xfrm flipV="1">
            <a:off x="5587659" y="2457332"/>
            <a:ext cx="290271" cy="10837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2">
            <a:extLst>
              <a:ext uri="{FF2B5EF4-FFF2-40B4-BE49-F238E27FC236}">
                <a16:creationId xmlns:a16="http://schemas.microsoft.com/office/drawing/2014/main" id="{2E41C63F-0006-49FC-8812-1A46C1538003}"/>
              </a:ext>
            </a:extLst>
          </p:cNvPr>
          <p:cNvSpPr txBox="1"/>
          <p:nvPr/>
        </p:nvSpPr>
        <p:spPr>
          <a:xfrm>
            <a:off x="4179115" y="4184790"/>
            <a:ext cx="37702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3B3C503A-0935-4887-B677-4F68BE8481B6}"/>
              </a:ext>
            </a:extLst>
          </p:cNvPr>
          <p:cNvCxnSpPr>
            <a:cxnSpLocks/>
          </p:cNvCxnSpPr>
          <p:nvPr/>
        </p:nvCxnSpPr>
        <p:spPr>
          <a:xfrm flipH="1">
            <a:off x="4308797" y="3996111"/>
            <a:ext cx="117662" cy="5865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2">
            <a:extLst>
              <a:ext uri="{FF2B5EF4-FFF2-40B4-BE49-F238E27FC236}">
                <a16:creationId xmlns:a16="http://schemas.microsoft.com/office/drawing/2014/main" id="{30B6FDB6-7848-483C-A76E-D46982F75F4B}"/>
              </a:ext>
            </a:extLst>
          </p:cNvPr>
          <p:cNvSpPr txBox="1"/>
          <p:nvPr/>
        </p:nvSpPr>
        <p:spPr>
          <a:xfrm>
            <a:off x="4133006" y="3734557"/>
            <a:ext cx="44114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a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90EE3318-FC5A-4E82-9B55-509A5A1EFD34}"/>
              </a:ext>
            </a:extLst>
          </p:cNvPr>
          <p:cNvCxnSpPr>
            <a:cxnSpLocks/>
          </p:cNvCxnSpPr>
          <p:nvPr/>
        </p:nvCxnSpPr>
        <p:spPr>
          <a:xfrm flipH="1" flipV="1">
            <a:off x="4187831" y="4175352"/>
            <a:ext cx="36037" cy="12485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2">
            <a:extLst>
              <a:ext uri="{FF2B5EF4-FFF2-40B4-BE49-F238E27FC236}">
                <a16:creationId xmlns:a16="http://schemas.microsoft.com/office/drawing/2014/main" id="{28620380-642B-4979-B5B0-0918C7811D41}"/>
              </a:ext>
            </a:extLst>
          </p:cNvPr>
          <p:cNvSpPr txBox="1"/>
          <p:nvPr/>
        </p:nvSpPr>
        <p:spPr>
          <a:xfrm>
            <a:off x="5379910" y="2522934"/>
            <a:ext cx="41549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c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3A0C42E5-70C1-4ED2-8AA2-D7AB5FF6F4C9}"/>
              </a:ext>
            </a:extLst>
          </p:cNvPr>
          <p:cNvCxnSpPr>
            <a:cxnSpLocks/>
          </p:cNvCxnSpPr>
          <p:nvPr/>
        </p:nvCxnSpPr>
        <p:spPr>
          <a:xfrm flipH="1">
            <a:off x="8849866" y="3760748"/>
            <a:ext cx="196707" cy="198263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2">
            <a:extLst>
              <a:ext uri="{FF2B5EF4-FFF2-40B4-BE49-F238E27FC236}">
                <a16:creationId xmlns:a16="http://schemas.microsoft.com/office/drawing/2014/main" id="{58ADFBB3-B221-4116-A10C-EBEDACCEAF72}"/>
              </a:ext>
            </a:extLst>
          </p:cNvPr>
          <p:cNvSpPr txBox="1"/>
          <p:nvPr/>
        </p:nvSpPr>
        <p:spPr>
          <a:xfrm>
            <a:off x="5130691" y="1117366"/>
            <a:ext cx="332142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S</a:t>
            </a:r>
          </a:p>
        </p:txBody>
      </p:sp>
      <p:sp>
        <p:nvSpPr>
          <p:cNvPr id="54" name="TextBox 2">
            <a:extLst>
              <a:ext uri="{FF2B5EF4-FFF2-40B4-BE49-F238E27FC236}">
                <a16:creationId xmlns:a16="http://schemas.microsoft.com/office/drawing/2014/main" id="{58ADFBB3-B221-4116-A10C-EBEDACCEAF72}"/>
              </a:ext>
            </a:extLst>
          </p:cNvPr>
          <p:cNvSpPr txBox="1"/>
          <p:nvPr/>
        </p:nvSpPr>
        <p:spPr>
          <a:xfrm>
            <a:off x="1256329" y="292802"/>
            <a:ext cx="434734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C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BB602ED0-8D1A-48A5-B5C5-6304F3AA85F9}"/>
              </a:ext>
            </a:extLst>
          </p:cNvPr>
          <p:cNvCxnSpPr>
            <a:stCxn id="54" idx="1"/>
          </p:cNvCxnSpPr>
          <p:nvPr/>
        </p:nvCxnSpPr>
        <p:spPr>
          <a:xfrm flipH="1">
            <a:off x="1144057" y="408218"/>
            <a:ext cx="112272" cy="118687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90EE3318-FC5A-4E82-9B55-509A5A1EFD34}"/>
              </a:ext>
            </a:extLst>
          </p:cNvPr>
          <p:cNvCxnSpPr>
            <a:cxnSpLocks/>
          </p:cNvCxnSpPr>
          <p:nvPr/>
        </p:nvCxnSpPr>
        <p:spPr>
          <a:xfrm flipH="1" flipV="1">
            <a:off x="4949831" y="5775837"/>
            <a:ext cx="36037" cy="12485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2">
            <a:extLst>
              <a:ext uri="{FF2B5EF4-FFF2-40B4-BE49-F238E27FC236}">
                <a16:creationId xmlns:a16="http://schemas.microsoft.com/office/drawing/2014/main" id="{2E41C63F-0006-49FC-8812-1A46C1538003}"/>
              </a:ext>
            </a:extLst>
          </p:cNvPr>
          <p:cNvSpPr txBox="1"/>
          <p:nvPr/>
        </p:nvSpPr>
        <p:spPr>
          <a:xfrm>
            <a:off x="4916948" y="5822415"/>
            <a:ext cx="35137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E7DD30A6-E92F-4069-B34E-36A8BCC5B58A}"/>
              </a:ext>
            </a:extLst>
          </p:cNvPr>
          <p:cNvCxnSpPr/>
          <p:nvPr/>
        </p:nvCxnSpPr>
        <p:spPr>
          <a:xfrm flipV="1">
            <a:off x="9533409" y="5774554"/>
            <a:ext cx="216512" cy="54185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2">
            <a:extLst>
              <a:ext uri="{FF2B5EF4-FFF2-40B4-BE49-F238E27FC236}">
                <a16:creationId xmlns:a16="http://schemas.microsoft.com/office/drawing/2014/main" id="{58ADFBB3-B221-4116-A10C-EBEDACCEAF72}"/>
              </a:ext>
            </a:extLst>
          </p:cNvPr>
          <p:cNvSpPr txBox="1"/>
          <p:nvPr/>
        </p:nvSpPr>
        <p:spPr>
          <a:xfrm>
            <a:off x="9259630" y="5732479"/>
            <a:ext cx="338554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P</a:t>
            </a:r>
          </a:p>
        </p:txBody>
      </p:sp>
    </p:spTree>
    <p:extLst>
      <p:ext uri="{BB962C8B-B14F-4D97-AF65-F5344CB8AC3E}">
        <p14:creationId xmlns:p14="http://schemas.microsoft.com/office/powerpoint/2010/main" val="37452666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2" y="329786"/>
            <a:ext cx="11470994" cy="6528207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79EFC3EC-2440-4126-A7FA-C8851713A521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2709DEC-0DEE-475F-921B-CC89FB28D4FB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E50D77A-FBED-4788-AADF-9F277D78DAE3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E087674-1E5F-467E-BC0B-60ABFBA2640A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3F40EB-1D01-45C7-A8B6-5F6B81B7A48D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6C6DE2F-13B2-428E-AED6-B13F9516AFC6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1A0E14C-B34E-435E-9B94-C3ADA34B5BA0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CF1AE1B-1240-4B1E-9441-D866ED8E4278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555FF93-EF23-4C4E-B797-80D39A692C3C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DFFF373-53CE-409E-9CBC-782F99A28DE0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319BB92-4495-4F86-8278-74D26FE4B43A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3EEFCC8-BD6B-45A1-BFCF-CCCD948238F1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38EDF88-50D5-4C25-800A-EB518B987F4E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E611E1B-2A37-4789-9A4B-554B2FB27E09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BA9C4BC-0AF8-4ABD-BD6A-F03413209F27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75B215C-611B-402C-8143-CA78B21B37E1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16BA3E8-20C1-49A9-93E2-6CE3FF68FF51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0DC9CFD-567A-445B-A4F6-D512A5474CE9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0253984-427E-4833-A276-EAED7C89C7B6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28AE081-3E0E-43F3-ACD1-734E6F641D1C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4887F02-E516-4A91-9FFE-02865D26CDB2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E7232391-052A-4135-BD63-A451E23EA9F0}"/>
              </a:ext>
            </a:extLst>
          </p:cNvPr>
          <p:cNvCxnSpPr/>
          <p:nvPr/>
        </p:nvCxnSpPr>
        <p:spPr>
          <a:xfrm flipH="1">
            <a:off x="4236019" y="3892156"/>
            <a:ext cx="88812" cy="130433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A1C608A4-E8AE-4A5D-B1D4-647FF4BF6998}"/>
              </a:ext>
            </a:extLst>
          </p:cNvPr>
          <p:cNvSpPr txBox="1"/>
          <p:nvPr/>
        </p:nvSpPr>
        <p:spPr>
          <a:xfrm>
            <a:off x="4091912" y="3695899"/>
            <a:ext cx="44114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a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7EEC1114-65BA-45AA-BA61-82F08ACC38F5}"/>
              </a:ext>
            </a:extLst>
          </p:cNvPr>
          <p:cNvCxnSpPr>
            <a:cxnSpLocks/>
          </p:cNvCxnSpPr>
          <p:nvPr/>
        </p:nvCxnSpPr>
        <p:spPr>
          <a:xfrm flipH="1">
            <a:off x="2225560" y="3823385"/>
            <a:ext cx="64938" cy="138906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E9602623-AB91-4EAB-A1EC-A97EE286A7C4}"/>
              </a:ext>
            </a:extLst>
          </p:cNvPr>
          <p:cNvSpPr txBox="1"/>
          <p:nvPr/>
        </p:nvSpPr>
        <p:spPr>
          <a:xfrm>
            <a:off x="2196374" y="3624350"/>
            <a:ext cx="44755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m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7F9F53E2-EF80-444A-B760-9F0896922960}"/>
              </a:ext>
            </a:extLst>
          </p:cNvPr>
          <p:cNvCxnSpPr>
            <a:cxnSpLocks/>
          </p:cNvCxnSpPr>
          <p:nvPr/>
        </p:nvCxnSpPr>
        <p:spPr>
          <a:xfrm flipH="1" flipV="1">
            <a:off x="4212050" y="4122785"/>
            <a:ext cx="68375" cy="154162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B65059ED-D733-440F-8631-EA6C2AA99F74}"/>
              </a:ext>
            </a:extLst>
          </p:cNvPr>
          <p:cNvSpPr txBox="1"/>
          <p:nvPr/>
        </p:nvSpPr>
        <p:spPr>
          <a:xfrm>
            <a:off x="4091912" y="4192745"/>
            <a:ext cx="37702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R</a:t>
            </a:r>
            <a:endParaRPr lang="fi-FI" sz="900" b="1" dirty="0" err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B7C888F4-0EA7-422C-81F1-EAD53A2019D3}"/>
              </a:ext>
            </a:extLst>
          </p:cNvPr>
          <p:cNvGrpSpPr/>
          <p:nvPr/>
        </p:nvGrpSpPr>
        <p:grpSpPr>
          <a:xfrm>
            <a:off x="1605641" y="4409720"/>
            <a:ext cx="950422" cy="777240"/>
            <a:chOff x="1605641" y="4409720"/>
            <a:chExt cx="950422" cy="777240"/>
          </a:xfrm>
        </p:grpSpPr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465693A5-2DF9-4DDF-88C1-A7D92D6318DD}"/>
                </a:ext>
              </a:extLst>
            </p:cNvPr>
            <p:cNvSpPr/>
            <p:nvPr/>
          </p:nvSpPr>
          <p:spPr>
            <a:xfrm>
              <a:off x="1615801" y="5111032"/>
              <a:ext cx="914911" cy="75927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59DA13E4-68A1-43CA-8074-ACF37DA7759F}"/>
                </a:ext>
              </a:extLst>
            </p:cNvPr>
            <p:cNvSpPr/>
            <p:nvPr/>
          </p:nvSpPr>
          <p:spPr>
            <a:xfrm>
              <a:off x="1605641" y="4409720"/>
              <a:ext cx="122185" cy="77724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236FAB67-73F0-4521-8067-BB60625CEDE8}"/>
                </a:ext>
              </a:extLst>
            </p:cNvPr>
            <p:cNvSpPr/>
            <p:nvPr/>
          </p:nvSpPr>
          <p:spPr>
            <a:xfrm>
              <a:off x="2433878" y="4409720"/>
              <a:ext cx="122185" cy="77724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E9602623-AB91-4EAB-A1EC-A97EE286A7C4}"/>
              </a:ext>
            </a:extLst>
          </p:cNvPr>
          <p:cNvSpPr txBox="1"/>
          <p:nvPr/>
        </p:nvSpPr>
        <p:spPr>
          <a:xfrm>
            <a:off x="2202786" y="279193"/>
            <a:ext cx="434734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C</a:t>
            </a: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7EEC1114-65BA-45AA-BA61-82F08ACC38F5}"/>
              </a:ext>
            </a:extLst>
          </p:cNvPr>
          <p:cNvCxnSpPr>
            <a:cxnSpLocks/>
          </p:cNvCxnSpPr>
          <p:nvPr/>
        </p:nvCxnSpPr>
        <p:spPr>
          <a:xfrm flipH="1">
            <a:off x="2085759" y="459926"/>
            <a:ext cx="204739" cy="116566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E9602623-AB91-4EAB-A1EC-A97EE286A7C4}"/>
              </a:ext>
            </a:extLst>
          </p:cNvPr>
          <p:cNvSpPr txBox="1"/>
          <p:nvPr/>
        </p:nvSpPr>
        <p:spPr>
          <a:xfrm>
            <a:off x="2267807" y="736102"/>
            <a:ext cx="332142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S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EF83542A-939F-4EE5-B74E-B7C570F2ADB1}"/>
              </a:ext>
            </a:extLst>
          </p:cNvPr>
          <p:cNvCxnSpPr>
            <a:cxnSpLocks/>
          </p:cNvCxnSpPr>
          <p:nvPr/>
        </p:nvCxnSpPr>
        <p:spPr>
          <a:xfrm flipH="1" flipV="1">
            <a:off x="2132868" y="701671"/>
            <a:ext cx="225955" cy="70307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E9602623-AB91-4EAB-A1EC-A97EE286A7C4}"/>
              </a:ext>
            </a:extLst>
          </p:cNvPr>
          <p:cNvSpPr txBox="1"/>
          <p:nvPr/>
        </p:nvSpPr>
        <p:spPr>
          <a:xfrm>
            <a:off x="1238764" y="6586424"/>
            <a:ext cx="35137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EF83542A-939F-4EE5-B74E-B7C570F2ADB1}"/>
              </a:ext>
            </a:extLst>
          </p:cNvPr>
          <p:cNvCxnSpPr>
            <a:cxnSpLocks/>
          </p:cNvCxnSpPr>
          <p:nvPr/>
        </p:nvCxnSpPr>
        <p:spPr>
          <a:xfrm flipH="1" flipV="1">
            <a:off x="1196447" y="6532582"/>
            <a:ext cx="118908" cy="118665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6295205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3" y="329786"/>
            <a:ext cx="11470992" cy="6528207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BEF3C692-9A72-4AE8-8648-518E0193D7E7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.0 mm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0794D37-276C-4EB2-81E2-B2010659B1C8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893EA47-67F3-4DB8-AF00-528695D8EF25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833B18B-FCD5-4CF2-9BDF-C13D3BC99DEF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C319DC-8EB0-4441-AD30-B4DEBEAB9E7D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A255BFA-FAED-47E9-8701-8DECE7F0AF19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DEA4835-1F27-4404-BE9C-6156B8949E57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30AFDFE-837B-491D-9103-D7290522D40A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66EC7B7-1DA3-48B5-A0E3-42B74B7D6A8B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74DFE2C-931E-4AE4-8CCD-E528D0F0AA79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832E9E6-CB83-44EB-9EAF-900A7DDA823B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E27C006-72B4-455B-B4AF-9D9C0016C9BA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AAA0768-BCE1-471D-AA8A-C357842996F1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79E855E-2B11-49AC-A5EE-82ECBAF76038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2E177BB-E7D2-4D4E-A9DB-DDB278560F9F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7E3CB1E-75CA-4B87-B8D0-D4214902AB78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DB4B895-77AB-47BD-8A15-22D7E7284159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4A6CF1B-9373-4D09-93C8-9DC6E5E6F4D3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84C1450-894C-4FCA-9E45-97EC94AC8EA5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8228956-5B31-4D6B-8FB2-40F72269639D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F418131-6FE1-47AC-85EE-70E57E2B0378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ABBF285E-E69F-4ED2-B917-3A0171ABC0A8}"/>
              </a:ext>
            </a:extLst>
          </p:cNvPr>
          <p:cNvCxnSpPr/>
          <p:nvPr/>
        </p:nvCxnSpPr>
        <p:spPr>
          <a:xfrm flipV="1">
            <a:off x="867653" y="687411"/>
            <a:ext cx="249947" cy="218498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28EA19D0-1FB6-4FBC-A329-2188043277D4}"/>
              </a:ext>
            </a:extLst>
          </p:cNvPr>
          <p:cNvSpPr txBox="1"/>
          <p:nvPr/>
        </p:nvSpPr>
        <p:spPr>
          <a:xfrm>
            <a:off x="681508" y="829898"/>
            <a:ext cx="28725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</a:t>
            </a:r>
            <a:endParaRPr lang="fi-FI" sz="900" b="1" dirty="0" err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A7D4479D-2E10-4607-9CBA-BB4ED3B94351}"/>
              </a:ext>
            </a:extLst>
          </p:cNvPr>
          <p:cNvCxnSpPr>
            <a:cxnSpLocks/>
          </p:cNvCxnSpPr>
          <p:nvPr/>
        </p:nvCxnSpPr>
        <p:spPr>
          <a:xfrm>
            <a:off x="919334" y="530313"/>
            <a:ext cx="173012" cy="7444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084F831-F302-4729-903A-C8F1B2600BD4}"/>
              </a:ext>
            </a:extLst>
          </p:cNvPr>
          <p:cNvSpPr txBox="1"/>
          <p:nvPr/>
        </p:nvSpPr>
        <p:spPr>
          <a:xfrm>
            <a:off x="657694" y="367936"/>
            <a:ext cx="332142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</a:t>
            </a:r>
            <a:endParaRPr lang="fi-FI" sz="900" b="1" dirty="0" err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EDDC812D-774F-42A4-B000-9EF5961E70D9}"/>
              </a:ext>
            </a:extLst>
          </p:cNvPr>
          <p:cNvCxnSpPr>
            <a:cxnSpLocks/>
          </p:cNvCxnSpPr>
          <p:nvPr/>
        </p:nvCxnSpPr>
        <p:spPr>
          <a:xfrm flipH="1" flipV="1">
            <a:off x="3081038" y="4058607"/>
            <a:ext cx="132062" cy="14435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6AEE74A-5EBE-4820-867D-F6D8D9CD883D}"/>
              </a:ext>
            </a:extLst>
          </p:cNvPr>
          <p:cNvSpPr txBox="1"/>
          <p:nvPr/>
        </p:nvSpPr>
        <p:spPr>
          <a:xfrm>
            <a:off x="5045497" y="4096746"/>
            <a:ext cx="44114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a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6AEE74A-5EBE-4820-867D-F6D8D9CD883D}"/>
              </a:ext>
            </a:extLst>
          </p:cNvPr>
          <p:cNvSpPr txBox="1"/>
          <p:nvPr/>
        </p:nvSpPr>
        <p:spPr>
          <a:xfrm>
            <a:off x="3122801" y="4143677"/>
            <a:ext cx="41549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c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EDDC812D-774F-42A4-B000-9EF5961E70D9}"/>
              </a:ext>
            </a:extLst>
          </p:cNvPr>
          <p:cNvCxnSpPr>
            <a:cxnSpLocks/>
          </p:cNvCxnSpPr>
          <p:nvPr/>
        </p:nvCxnSpPr>
        <p:spPr>
          <a:xfrm flipH="1" flipV="1">
            <a:off x="5130506" y="4025901"/>
            <a:ext cx="92369" cy="117776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703828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3" y="329786"/>
            <a:ext cx="11470992" cy="6528206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85B0809F-FB10-4B3B-BA2D-B219F59BFD02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D98BBEE-E832-4F15-A149-C4FB7ACA2D83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64CD4C3-8ED1-4461-922C-498EC487AFCB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415754-45F9-4241-9AE7-52800E874A4B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56AE6AE-1BC8-4AFF-85A3-4B6A41050CC1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CDFDAEB-C197-454D-93AB-E16237821CAD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DB85003-3314-4157-B66A-D726CF0E186A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6A8257A-B8AE-47DE-9F0F-268C4888E9E5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8FE2A2C-1AD9-4F0A-AE56-516ECDB2C8D6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14462B2-5701-46DA-896E-62D56C2ECCAA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ACA7261-2526-4ADD-9AC3-DD37DBDAC1D2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7984145-1733-4233-A68E-B5752CCB9BA4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D0373B8-2379-4E5F-AE87-0A63656C79E6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DA60300-6B98-4102-A71A-877E37904FD3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17F0D25-D332-4FAE-9D13-FCB2C51BE644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F7F0F89-D166-4EED-A17E-92FC670F3773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9E486CA-8056-4CC6-8CC3-66B4B6C51AC1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8484A38-5116-4770-9C07-AEF76E58E4EF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51A6E7E-0F2A-4FC8-9CBD-9BC555B74223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0AB0B80-0864-4F33-B112-C5AA4E1D26A3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C74DFBC-0351-420F-8E37-C48253B92BA2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DB98C1B1-3926-45E2-BE33-6ADF08D18E47}"/>
              </a:ext>
            </a:extLst>
          </p:cNvPr>
          <p:cNvCxnSpPr/>
          <p:nvPr/>
        </p:nvCxnSpPr>
        <p:spPr>
          <a:xfrm flipV="1">
            <a:off x="913372" y="685800"/>
            <a:ext cx="201587" cy="220108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A551FFE1-9E90-469D-BD91-8B3EBD5737AA}"/>
              </a:ext>
            </a:extLst>
          </p:cNvPr>
          <p:cNvSpPr txBox="1"/>
          <p:nvPr/>
        </p:nvSpPr>
        <p:spPr>
          <a:xfrm>
            <a:off x="681508" y="829898"/>
            <a:ext cx="28725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</a:t>
            </a:r>
            <a:endParaRPr lang="fi-FI" sz="900" b="1" dirty="0" err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5E019A18-A8B1-4C91-B2FF-D7FF18366A0A}"/>
              </a:ext>
            </a:extLst>
          </p:cNvPr>
          <p:cNvCxnSpPr>
            <a:cxnSpLocks/>
          </p:cNvCxnSpPr>
          <p:nvPr/>
        </p:nvCxnSpPr>
        <p:spPr>
          <a:xfrm>
            <a:off x="970522" y="534430"/>
            <a:ext cx="172478" cy="64337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AD78D7F6-2B6A-4E8B-B89A-2F76B753DB60}"/>
              </a:ext>
            </a:extLst>
          </p:cNvPr>
          <p:cNvSpPr txBox="1"/>
          <p:nvPr/>
        </p:nvSpPr>
        <p:spPr>
          <a:xfrm>
            <a:off x="657693" y="367935"/>
            <a:ext cx="332142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</a:t>
            </a:r>
            <a:endParaRPr lang="fi-FI" sz="900" b="1" dirty="0" err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DB98C1B1-3926-45E2-BE33-6ADF08D18E47}"/>
              </a:ext>
            </a:extLst>
          </p:cNvPr>
          <p:cNvCxnSpPr/>
          <p:nvPr/>
        </p:nvCxnSpPr>
        <p:spPr>
          <a:xfrm flipH="1" flipV="1">
            <a:off x="3111500" y="4061263"/>
            <a:ext cx="117475" cy="115415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A551FFE1-9E90-469D-BD91-8B3EBD5737AA}"/>
              </a:ext>
            </a:extLst>
          </p:cNvPr>
          <p:cNvSpPr txBox="1"/>
          <p:nvPr/>
        </p:nvSpPr>
        <p:spPr>
          <a:xfrm>
            <a:off x="3082991" y="4118970"/>
            <a:ext cx="460382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m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52359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4" y="329786"/>
            <a:ext cx="11470990" cy="6528206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3324E30C-1D49-4CB4-82AB-25A95787B1B9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7F386AC-84CD-4B0B-B9FC-7AB532D8697D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4ED6815-AD0A-4B95-9984-F9C2AE945C08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8BFA280-9965-41A1-A34E-FF55F87B8537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680E2BF-87F7-4FBA-B538-235B49670971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1EB516A-F8BF-4AFD-8890-AABE30BAB6A9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422DC70-77B4-4260-A5BA-6BD0BB010E4D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C65929E-9DA7-4F45-905A-B73CC2EDD243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E015C76-D9C1-41ED-9A99-94C4D30461FA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DED2A2C-0A05-4389-A91F-A2B5F2B7562F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1B5ADF2-17FA-4D18-B744-CC98A3A084D3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F4F4AE4-7815-4ADF-824E-03EF0840F607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D8D36D9-104C-4EEB-9457-D35CFE786C1C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7A7692D-1577-410F-9D59-E15C45247B4E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FF1E3CB-3997-4779-A1C0-BD101EA33EB8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F0670AE-06AC-4AF9-AEDA-418FF0D9A9B4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2BE1C23-252A-488C-960E-0E7EBC38BABB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00B2B36-42E0-4542-80D9-556F705FA3F9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75B2679-CA18-4793-A940-DB8B31E8D936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4002D66-A334-4089-AC48-3C6A6EBE01B6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287426A-8892-4155-9A2D-1502AA913661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07FDFF02-B0F2-45A6-87B0-017414D1C0D5}"/>
              </a:ext>
            </a:extLst>
          </p:cNvPr>
          <p:cNvGrpSpPr/>
          <p:nvPr/>
        </p:nvGrpSpPr>
        <p:grpSpPr>
          <a:xfrm>
            <a:off x="10210289" y="1145541"/>
            <a:ext cx="950423" cy="777240"/>
            <a:chOff x="10210289" y="1145541"/>
            <a:chExt cx="950423" cy="777240"/>
          </a:xfrm>
          <a:solidFill>
            <a:schemeClr val="tx1"/>
          </a:solidFill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EE4EF86A-0B75-4F0A-AAE2-B3B85CB4A0CF}"/>
                </a:ext>
              </a:extLst>
            </p:cNvPr>
            <p:cNvSpPr/>
            <p:nvPr/>
          </p:nvSpPr>
          <p:spPr>
            <a:xfrm>
              <a:off x="10220449" y="1846853"/>
              <a:ext cx="914911" cy="75927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2CB281B4-CF78-4AB1-BCEE-B9D1E8E58267}"/>
                </a:ext>
              </a:extLst>
            </p:cNvPr>
            <p:cNvSpPr/>
            <p:nvPr/>
          </p:nvSpPr>
          <p:spPr>
            <a:xfrm>
              <a:off x="10210289" y="1145541"/>
              <a:ext cx="203712" cy="77724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FB671F84-AC19-4DE8-BFDE-392D25150DA2}"/>
                </a:ext>
              </a:extLst>
            </p:cNvPr>
            <p:cNvSpPr/>
            <p:nvPr/>
          </p:nvSpPr>
          <p:spPr>
            <a:xfrm>
              <a:off x="10957000" y="1145541"/>
              <a:ext cx="203712" cy="77724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3898520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39" y="329786"/>
            <a:ext cx="11471002" cy="652821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D474CD6-D906-4279-95E5-C994B6C7BEC7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5959E9-427E-4F8B-A97F-E3B63F6168D7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1D5BA1-8E76-4F6F-9BFA-883097D188AF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6BDA013-F616-4E5C-91B4-5CCB7AC08CF3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F88A11C-37D3-48A6-AA1B-FFB7855AB10E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9C40A66-46B7-40C8-8019-2C47FD46ADCC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954E08A-EBEB-470A-87F5-C0EDFD50A157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197D6B6-44A1-4D32-A57C-C82BE5EBB376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8CCE87C-3849-4718-8E1F-5FCF57895FEE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2A096E3-A6A0-425E-A6C1-C00557880984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7FE21A4-8D79-4462-88B5-3B953B24E4A2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F0C859D-B48A-4126-AF9C-49D888D6E449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C7C4785-1F67-4193-8CFF-A4F12D39F0C8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067D493-05E0-4537-A20F-40BBBF0D0F0D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A05EFAE-F4B8-4AD4-A9C0-764BB4D6B60A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41C89A8-091D-492D-BE1A-F7C41E2017B5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7D24A91-9975-4390-9B7E-452E4B402BDE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841093A-3EE4-4A98-9D80-3AAE4160F41C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2607173-F24B-438C-B0F5-7F06435F963E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48C54E9-8C89-497A-BCFD-BAFD80F79569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8685498-A451-4BA1-AA4F-50752615B65B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.0 mm</a:t>
            </a:r>
          </a:p>
        </p:txBody>
      </p:sp>
    </p:spTree>
    <p:extLst>
      <p:ext uri="{BB962C8B-B14F-4D97-AF65-F5344CB8AC3E}">
        <p14:creationId xmlns:p14="http://schemas.microsoft.com/office/powerpoint/2010/main" val="35994823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224" y="329184"/>
            <a:ext cx="11471002" cy="6528212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27A3F554-558F-4FB2-A517-12D8C3B60F35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8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EC63ED5-8BC2-45DA-9B74-989F3646C69C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D4A2698-CD98-4AEE-92B7-23EC7408215C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4E571B6-A295-45C6-ACCF-9D91459F0629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17D7E0A-AE81-4713-A27A-CC0C88A7BB9C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D9C061B-8A1F-4CC8-A6FC-D5E1588B0B13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256DCD1-0325-4B1E-BC71-BD5B3C5676E1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DA5E180-34E1-4C95-AC7D-2F5D2424D7F8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B178046-5F2B-40D7-905D-5488337E9D8B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643A4C1-53F6-49BA-827B-CF5F65E684ED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DC772A4-973A-4AB9-99CF-42362AF8FB09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0183E24-61EA-4A83-B513-B17E01AE1C7C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F0808BA-F159-4AF1-9B26-D9D40274D19E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09D763F-8B1A-4C78-B4F9-5CEDA3091829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613199B-32C2-44EB-BC0D-4E8A3EC9AD4A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807A904-ECA4-4BF1-B8D7-85825BB03696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10DF341-D29F-427F-99F3-A5663F1FB6C8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32319D8-FA5E-448D-B78A-6B05F5231AC9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8F8935B-99DF-4009-9111-94E2517598F4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268FCD8-DA10-4CF4-83D4-61A4BBCB91FD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D252799-E5F6-4CE9-9EDF-64DBAFB11F3D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171" name="Straight Arrow Connector 170">
            <a:extLst>
              <a:ext uri="{FF2B5EF4-FFF2-40B4-BE49-F238E27FC236}">
                <a16:creationId xmlns:a16="http://schemas.microsoft.com/office/drawing/2014/main" id="{3D4FD31D-BF5A-422A-865D-E86612F5259E}"/>
              </a:ext>
            </a:extLst>
          </p:cNvPr>
          <p:cNvCxnSpPr/>
          <p:nvPr/>
        </p:nvCxnSpPr>
        <p:spPr>
          <a:xfrm>
            <a:off x="6122423" y="1295107"/>
            <a:ext cx="44424" cy="126826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2">
            <a:extLst>
              <a:ext uri="{FF2B5EF4-FFF2-40B4-BE49-F238E27FC236}">
                <a16:creationId xmlns:a16="http://schemas.microsoft.com/office/drawing/2014/main" id="{6801AC26-D066-42C8-964B-E228F62F25F4}"/>
              </a:ext>
            </a:extLst>
          </p:cNvPr>
          <p:cNvSpPr txBox="1"/>
          <p:nvPr/>
        </p:nvSpPr>
        <p:spPr>
          <a:xfrm>
            <a:off x="5850554" y="1095273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Tm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98174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39" y="329786"/>
            <a:ext cx="11471001" cy="6528212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2CF65943-57AF-46B5-B91A-D64808EE6095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7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5E6820B-ED34-432C-8D02-A07C39525999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E9C6AFD-B672-407C-9DD3-2EBE209A33AD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868F60D-ACB4-4A80-899E-4FB9AD88731E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23A1065-BBB5-41D1-8C25-CB1BF4A7C056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B2AE755-CC6D-4F9D-B49B-4DD8C83C7E49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5707E1E-B4ED-4859-987C-8B9E63950C4B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240DB0C-5864-4D58-B246-1EFD14577081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5F21712-9B1C-4EF0-90B3-9DF4FF265107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B9EF7CC-3780-493A-A299-AE06833A4D78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67BA7CD-D2E0-4A83-A66D-0644BF635B73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DBECB15-19FF-48D6-9011-B9424F23A89C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3462A8A-081A-466C-BBD5-F07CE01860F3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B84906A-2A1B-435E-B891-175689BA8570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3CF480E-5E54-495A-AF35-A4A24E3E4B55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2974387-0520-482C-B477-BD24F0AFFB08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24DFF6D-7141-4DFC-8381-B2EE17A68967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37088CD-53B1-4CE2-828C-2D43903D534E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4083EBF-058B-4E4E-8923-0D9C55177049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D7CD7AB-50E0-4847-8939-C3CF851ED37E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3399E61-58FD-4894-BE80-07048A2DAD05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5C3EEB2A-5109-4C85-9123-15D0834ACF8B}"/>
              </a:ext>
            </a:extLst>
          </p:cNvPr>
          <p:cNvCxnSpPr/>
          <p:nvPr/>
        </p:nvCxnSpPr>
        <p:spPr>
          <a:xfrm flipH="1" flipV="1">
            <a:off x="2353629" y="2445534"/>
            <a:ext cx="92497" cy="131966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2">
            <a:extLst>
              <a:ext uri="{FF2B5EF4-FFF2-40B4-BE49-F238E27FC236}">
                <a16:creationId xmlns:a16="http://schemas.microsoft.com/office/drawing/2014/main" id="{B54A2E18-F8E4-48B2-B6EF-847065C35758}"/>
              </a:ext>
            </a:extLst>
          </p:cNvPr>
          <p:cNvSpPr txBox="1"/>
          <p:nvPr/>
        </p:nvSpPr>
        <p:spPr>
          <a:xfrm>
            <a:off x="2108745" y="2536917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Tm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84842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39" y="329786"/>
            <a:ext cx="11471001" cy="6528211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F5615BC6-0ACB-4209-AD7B-06F65A6D0F42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7CD2A95-CE9F-45D7-9764-DECF7EE4FC66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4CADC15-52BF-4D44-B41F-48BCC85E5A21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C6F0DFD-520B-426A-853C-A262BAF9DD76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06DEC00-5CF5-4AC2-8C97-414E4256DFAD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5389926-62AE-4727-A787-C6AA1EAFF90E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5CB7C15-E72D-4287-A344-71CE20A7EFCD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7F09C4F-EC97-4679-8EA0-E3A0BB6ABF30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3CC79F3-E5A1-4BF5-A61E-49A0CA59C347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D949294-B0FA-43D2-8BC7-648FF87D0DB5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F824E0C-2B36-4476-B966-779324BA5FBA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BAD6B75-54D6-416D-8DD8-BEAC1D179F42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7E8773F-ACF4-4C72-B368-3235880EEDA5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C3F12EA-C48C-4717-8911-F1FB709799F8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C00ECA6-DC5F-455C-9188-A072AC35775A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C2F5971-C260-4CB3-94E6-69EB7962778A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5FE463F-938A-477C-B5E9-DD10B8F67FBB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24E3CFE-E8DA-48FF-AA55-F1A1D44E8592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C5E58C0-67BD-423F-8B09-C79972124795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852487D-4A8C-4FD1-AE30-6CAD1EE37B68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D80B82C-18B3-492F-AD44-F8488301C285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sp>
        <p:nvSpPr>
          <p:cNvPr id="24" name="TextBox 2">
            <a:extLst>
              <a:ext uri="{FF2B5EF4-FFF2-40B4-BE49-F238E27FC236}">
                <a16:creationId xmlns:a16="http://schemas.microsoft.com/office/drawing/2014/main" id="{BBEEBE1E-AE7B-46D6-BDB3-3CD062851561}"/>
              </a:ext>
            </a:extLst>
          </p:cNvPr>
          <p:cNvSpPr txBox="1"/>
          <p:nvPr/>
        </p:nvSpPr>
        <p:spPr>
          <a:xfrm>
            <a:off x="2196488" y="2537708"/>
            <a:ext cx="41549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Cv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4207E26A-AE4C-4BDA-8C7E-7FB39427C3B6}"/>
              </a:ext>
            </a:extLst>
          </p:cNvPr>
          <p:cNvCxnSpPr/>
          <p:nvPr/>
        </p:nvCxnSpPr>
        <p:spPr>
          <a:xfrm flipH="1" flipV="1">
            <a:off x="2304463" y="2443724"/>
            <a:ext cx="126656" cy="135585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428191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0" y="329786"/>
            <a:ext cx="11470999" cy="6528211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6C60FC91-9130-49EE-ADBE-8F6AC0475A8A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5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58269D7-7055-432E-97CF-E6AFE3DCDE80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C84019A-1DB3-49D4-BBEF-FAB74018D5F3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E2A2578-9D8A-423C-9016-C3CCAF30FBD1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6CBA43A-5F3F-4236-AEAA-1A5B1813F7AB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798D36A-79D4-4ABD-93AB-B9BCCA8CB46E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DD8D281-A4BA-4003-99B0-E2E163011AE4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FF26B80-091D-4D09-9EAE-EA443468DE56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1CE47FA-C371-42A2-9820-296C871EAE6F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2E50B18-09D3-47EA-9794-8EEF3644FBBB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B0A1845-6D2E-41C8-904B-CE9966F83EC8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D18F279-AAFC-43AE-AE41-E7A86E0E5C5E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46DCF56-97D4-4534-8C45-924A1A6194F9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5DA484E-219B-421C-B604-E3A3B4B59DBB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8464FB1-952C-440E-8DFA-7E22F03B9ACE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BD60817-736D-43B4-80DE-C6BA8051DA3C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CE9106C-27B8-4052-AE6A-B47374D60B79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598A3EC-21E8-4345-A8A8-35CD3BBC9050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22BD4A7-AB58-4048-BF49-AC62904271DF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DD92239-0FBA-4748-9C7F-C62BA3D9C00F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EC4901F-5C6F-4BE3-BD3C-57BCE728110E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3C92C33F-EB84-445D-8944-2BA3DF1A6831}"/>
              </a:ext>
            </a:extLst>
          </p:cNvPr>
          <p:cNvCxnSpPr/>
          <p:nvPr/>
        </p:nvCxnSpPr>
        <p:spPr>
          <a:xfrm flipV="1">
            <a:off x="7012304" y="2483655"/>
            <a:ext cx="91150" cy="128372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2">
            <a:extLst>
              <a:ext uri="{FF2B5EF4-FFF2-40B4-BE49-F238E27FC236}">
                <a16:creationId xmlns:a16="http://schemas.microsoft.com/office/drawing/2014/main" id="{F0825726-BEA2-4485-BDF3-CEB9E45F0911}"/>
              </a:ext>
            </a:extLst>
          </p:cNvPr>
          <p:cNvSpPr txBox="1"/>
          <p:nvPr/>
        </p:nvSpPr>
        <p:spPr>
          <a:xfrm>
            <a:off x="6812321" y="2555967"/>
            <a:ext cx="41549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Cv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84463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0" y="329786"/>
            <a:ext cx="11470999" cy="652821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894173F0-158F-4092-AC9F-4C1DB42C02BA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4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5342BE7-5477-4939-A595-24C597631BC3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A5DB87D-40E3-4619-AC6B-DA20C34C776A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6427BB1-BBFC-4D2F-9D99-4C0CA720D622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CC3BBBF-7F45-4CA0-B731-51D7480629C5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4EFE9BB-EAC4-4494-8EAB-DB05B4A84A18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B1DD0AE-0439-469B-8AE2-113D990166B8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6FF02C4-E476-4817-8C9B-E4DA41D444A8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901C08F-A238-4775-9F72-90632695FCB1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28FE2D3-1E6B-42B8-92F5-1A8435893F08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397DBDB-76F0-41F3-9D52-E61A326A68A9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B08C1F2-98D5-432B-97C0-2856D95E3581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892ACA5-BB1B-4046-B6B4-473FF7879F42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1FD3F13-3545-4907-9082-4CFDC3C7B3B6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3F260EC-DCDB-429A-A254-4423536E887E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E85733F-F8E6-482D-BE50-FB73A6345E45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CC7ED2A-EF51-421D-9321-5CF8400B69E1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5DBF772-E90C-43BD-B3C0-BF1890C0A7F6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836668C-9219-4A0B-87D7-7DEE4F526818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4E54B65-157D-4CAD-BE95-57B17D674A03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335BC8E-BC4A-4F3C-B050-4131FBBC075A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sp>
        <p:nvSpPr>
          <p:cNvPr id="6" name="TextBox 2">
            <a:extLst>
              <a:ext uri="{FF2B5EF4-FFF2-40B4-BE49-F238E27FC236}">
                <a16:creationId xmlns:a16="http://schemas.microsoft.com/office/drawing/2014/main" id="{B2AC4670-8B46-428E-BE58-F5218221C136}"/>
              </a:ext>
            </a:extLst>
          </p:cNvPr>
          <p:cNvSpPr txBox="1"/>
          <p:nvPr/>
        </p:nvSpPr>
        <p:spPr>
          <a:xfrm>
            <a:off x="4675133" y="5809178"/>
            <a:ext cx="588623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Gco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D7BE4EAD-F302-4B56-96AC-90C65F24192E}"/>
              </a:ext>
            </a:extLst>
          </p:cNvPr>
          <p:cNvCxnSpPr/>
          <p:nvPr/>
        </p:nvCxnSpPr>
        <p:spPr>
          <a:xfrm flipV="1">
            <a:off x="4889494" y="5776404"/>
            <a:ext cx="105528" cy="96023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232606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1" y="329786"/>
            <a:ext cx="11470997" cy="652821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8BB2454C-E5AF-4952-B585-A16AD64FE6DB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3CF9519-FA58-45C6-8C2E-79FCFF2E9855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F518453-9DC2-4544-ACD8-AC0E0CCDF438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5124614-050B-4EF9-B06B-2E4102320AD3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469AEFC-F8C5-42BA-9B81-918D19C44A4F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CF46FAB-803F-4410-86F1-61814A0B39D8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4A0C6AE-6C36-4B45-9405-5CCC4CBD1542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2C6B010-A87B-4E16-AD6E-AEC850A929DD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CCCC29-76B8-414C-B1D6-09339C33CC74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E0805C8-DDCC-4F5D-AA1D-F4207DC8E2DE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FF7E6F8-20C7-4382-BDF3-89DB9E998EE2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2BE23CD-29BA-4892-88AA-13A42437A3AD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62682EA-64B1-4F4F-8272-264801352279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4CB599A-603B-4444-9D07-CFC49F07DC92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F619451-E3C8-4BA8-89D3-57CDED8BFB70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A629349-2BFB-4D82-ABBF-05A5ADE28957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463D1EE-3DF2-4CB3-B3D0-68A1B9569A1B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B9662D7-D9D9-4E52-94EE-775C6E83FD43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172FAF6-5B95-4696-B53E-B2D141F6CCC4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ED90753-9FF5-4665-A4D4-C94F3E05A064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3AF03B8-6900-435B-99BF-82351E625BF4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6E6651F-8681-49C3-A60F-0FE93F2223DE}"/>
              </a:ext>
            </a:extLst>
          </p:cNvPr>
          <p:cNvCxnSpPr/>
          <p:nvPr/>
        </p:nvCxnSpPr>
        <p:spPr>
          <a:xfrm flipV="1">
            <a:off x="5963446" y="4175925"/>
            <a:ext cx="87692" cy="87488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2">
            <a:extLst>
              <a:ext uri="{FF2B5EF4-FFF2-40B4-BE49-F238E27FC236}">
                <a16:creationId xmlns:a16="http://schemas.microsoft.com/office/drawing/2014/main" id="{5185E685-02D8-42BA-9729-47391C3EC14F}"/>
              </a:ext>
            </a:extLst>
          </p:cNvPr>
          <p:cNvSpPr txBox="1"/>
          <p:nvPr/>
        </p:nvSpPr>
        <p:spPr>
          <a:xfrm>
            <a:off x="5351921" y="4192875"/>
            <a:ext cx="761747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Gbm</a:t>
            </a:r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B239E4C2-A4F2-406C-9207-16DE00EB4D3C}"/>
              </a:ext>
            </a:extLst>
          </p:cNvPr>
          <p:cNvCxnSpPr/>
          <p:nvPr/>
        </p:nvCxnSpPr>
        <p:spPr>
          <a:xfrm flipV="1">
            <a:off x="6969166" y="4198601"/>
            <a:ext cx="91240" cy="129624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2">
            <a:extLst>
              <a:ext uri="{FF2B5EF4-FFF2-40B4-BE49-F238E27FC236}">
                <a16:creationId xmlns:a16="http://schemas.microsoft.com/office/drawing/2014/main" id="{A7CF9ED8-C481-4EAE-996F-43D08EE5E53F}"/>
              </a:ext>
            </a:extLst>
          </p:cNvPr>
          <p:cNvSpPr txBox="1"/>
          <p:nvPr/>
        </p:nvSpPr>
        <p:spPr>
          <a:xfrm>
            <a:off x="6316708" y="4190593"/>
            <a:ext cx="723275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Gco</a:t>
            </a:r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F5083C0F-885A-4BAE-86D0-3B5751B54756}"/>
              </a:ext>
            </a:extLst>
          </p:cNvPr>
          <p:cNvCxnSpPr/>
          <p:nvPr/>
        </p:nvCxnSpPr>
        <p:spPr>
          <a:xfrm flipH="1" flipV="1">
            <a:off x="11005888" y="4118186"/>
            <a:ext cx="43112" cy="121497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2">
            <a:extLst>
              <a:ext uri="{FF2B5EF4-FFF2-40B4-BE49-F238E27FC236}">
                <a16:creationId xmlns:a16="http://schemas.microsoft.com/office/drawing/2014/main" id="{8639B415-B443-4766-8BE4-60B53B8CB8C5}"/>
              </a:ext>
            </a:extLst>
          </p:cNvPr>
          <p:cNvSpPr txBox="1"/>
          <p:nvPr/>
        </p:nvSpPr>
        <p:spPr>
          <a:xfrm>
            <a:off x="10860487" y="4186150"/>
            <a:ext cx="37702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R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3356CEDA-FE42-4823-828D-D6D5ED2A670F}"/>
              </a:ext>
            </a:extLst>
          </p:cNvPr>
          <p:cNvCxnSpPr/>
          <p:nvPr/>
        </p:nvCxnSpPr>
        <p:spPr>
          <a:xfrm flipH="1">
            <a:off x="3153834" y="2958265"/>
            <a:ext cx="165099" cy="182868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2">
            <a:extLst>
              <a:ext uri="{FF2B5EF4-FFF2-40B4-BE49-F238E27FC236}">
                <a16:creationId xmlns:a16="http://schemas.microsoft.com/office/drawing/2014/main" id="{FD7291C0-3A21-47FB-AE34-3D6CF4A17729}"/>
              </a:ext>
            </a:extLst>
          </p:cNvPr>
          <p:cNvSpPr txBox="1"/>
          <p:nvPr/>
        </p:nvSpPr>
        <p:spPr>
          <a:xfrm>
            <a:off x="3153834" y="2779012"/>
            <a:ext cx="421910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A</a:t>
            </a:r>
          </a:p>
        </p:txBody>
      </p:sp>
      <p:sp>
        <p:nvSpPr>
          <p:cNvPr id="48" name="TextBox 2">
            <a:extLst>
              <a:ext uri="{FF2B5EF4-FFF2-40B4-BE49-F238E27FC236}">
                <a16:creationId xmlns:a16="http://schemas.microsoft.com/office/drawing/2014/main" id="{A7CF9ED8-C481-4EAE-996F-43D08EE5E53F}"/>
              </a:ext>
            </a:extLst>
          </p:cNvPr>
          <p:cNvSpPr txBox="1"/>
          <p:nvPr/>
        </p:nvSpPr>
        <p:spPr>
          <a:xfrm>
            <a:off x="4961080" y="1732292"/>
            <a:ext cx="550151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Gla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F5083C0F-885A-4BAE-86D0-3B5751B54756}"/>
              </a:ext>
            </a:extLst>
          </p:cNvPr>
          <p:cNvCxnSpPr/>
          <p:nvPr/>
        </p:nvCxnSpPr>
        <p:spPr>
          <a:xfrm flipH="1" flipV="1">
            <a:off x="5210756" y="1678160"/>
            <a:ext cx="108410" cy="108265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0233273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BEE7F6-1436-4427-A71D-87C174ADF7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241" y="329786"/>
            <a:ext cx="11470997" cy="6528209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DE171B81-179C-4B0C-8E95-EA7596DB764A}"/>
              </a:ext>
            </a:extLst>
          </p:cNvPr>
          <p:cNvSpPr txBox="1"/>
          <p:nvPr/>
        </p:nvSpPr>
        <p:spPr>
          <a:xfrm>
            <a:off x="-61546" y="0"/>
            <a:ext cx="1072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2.0 m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0313DDA-402C-4885-8AEE-20BBF808528D}"/>
              </a:ext>
            </a:extLst>
          </p:cNvPr>
          <p:cNvSpPr txBox="1"/>
          <p:nvPr/>
        </p:nvSpPr>
        <p:spPr>
          <a:xfrm>
            <a:off x="0" y="5100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6FC8D8E-B9B5-4307-BC7A-ACE7EEFB88F8}"/>
              </a:ext>
            </a:extLst>
          </p:cNvPr>
          <p:cNvSpPr txBox="1"/>
          <p:nvPr/>
        </p:nvSpPr>
        <p:spPr>
          <a:xfrm>
            <a:off x="0" y="13261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958CB94-0D01-4225-852F-6ED955F82032}"/>
              </a:ext>
            </a:extLst>
          </p:cNvPr>
          <p:cNvSpPr txBox="1"/>
          <p:nvPr/>
        </p:nvSpPr>
        <p:spPr>
          <a:xfrm>
            <a:off x="0" y="214218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23DF9B7-C5A9-4B8C-9B02-8FBA334FA09E}"/>
              </a:ext>
            </a:extLst>
          </p:cNvPr>
          <p:cNvSpPr txBox="1"/>
          <p:nvPr/>
        </p:nvSpPr>
        <p:spPr>
          <a:xfrm>
            <a:off x="0" y="295826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96924D5-ABD0-450D-93B7-59FA18CD3232}"/>
              </a:ext>
            </a:extLst>
          </p:cNvPr>
          <p:cNvSpPr txBox="1"/>
          <p:nvPr/>
        </p:nvSpPr>
        <p:spPr>
          <a:xfrm>
            <a:off x="0" y="377434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6F4CAB1-BD61-431E-8FA4-BD178E1C3BAD}"/>
              </a:ext>
            </a:extLst>
          </p:cNvPr>
          <p:cNvSpPr txBox="1"/>
          <p:nvPr/>
        </p:nvSpPr>
        <p:spPr>
          <a:xfrm>
            <a:off x="0" y="459042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6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DEA8E42-F69D-4768-9815-02846AA0E506}"/>
              </a:ext>
            </a:extLst>
          </p:cNvPr>
          <p:cNvSpPr txBox="1"/>
          <p:nvPr/>
        </p:nvSpPr>
        <p:spPr>
          <a:xfrm>
            <a:off x="0" y="5406505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7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0A5A185-1094-4647-9DFB-B397A01006A3}"/>
              </a:ext>
            </a:extLst>
          </p:cNvPr>
          <p:cNvSpPr txBox="1"/>
          <p:nvPr/>
        </p:nvSpPr>
        <p:spPr>
          <a:xfrm>
            <a:off x="0" y="6222583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#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3BEECD2-9D73-4329-9A47-B3178A74CD00}"/>
              </a:ext>
            </a:extLst>
          </p:cNvPr>
          <p:cNvSpPr txBox="1"/>
          <p:nvPr/>
        </p:nvSpPr>
        <p:spPr>
          <a:xfrm>
            <a:off x="1951231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 °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93D3959-96CD-4CAD-83B8-858884D69AD7}"/>
              </a:ext>
            </a:extLst>
          </p:cNvPr>
          <p:cNvSpPr txBox="1"/>
          <p:nvPr/>
        </p:nvSpPr>
        <p:spPr>
          <a:xfrm>
            <a:off x="2896622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 °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0EE17CD-93F2-4C27-B055-ACD426A93C4C}"/>
              </a:ext>
            </a:extLst>
          </p:cNvPr>
          <p:cNvSpPr txBox="1"/>
          <p:nvPr/>
        </p:nvSpPr>
        <p:spPr>
          <a:xfrm>
            <a:off x="384201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 °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EF316B8-A556-4BDD-93C5-9E3FEBD1BFD6}"/>
              </a:ext>
            </a:extLst>
          </p:cNvPr>
          <p:cNvSpPr txBox="1"/>
          <p:nvPr/>
        </p:nvSpPr>
        <p:spPr>
          <a:xfrm>
            <a:off x="4787404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20 °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77D8C38-0FF7-4F5A-AAFC-EE12D8304CC0}"/>
              </a:ext>
            </a:extLst>
          </p:cNvPr>
          <p:cNvSpPr txBox="1"/>
          <p:nvPr/>
        </p:nvSpPr>
        <p:spPr>
          <a:xfrm>
            <a:off x="5732795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0 °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8C81A4E-86BB-4079-BB42-641ACE841661}"/>
              </a:ext>
            </a:extLst>
          </p:cNvPr>
          <p:cNvSpPr txBox="1"/>
          <p:nvPr/>
        </p:nvSpPr>
        <p:spPr>
          <a:xfrm>
            <a:off x="6678186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0°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A634516-3540-4480-9601-6D7677412C07}"/>
              </a:ext>
            </a:extLst>
          </p:cNvPr>
          <p:cNvSpPr txBox="1"/>
          <p:nvPr/>
        </p:nvSpPr>
        <p:spPr>
          <a:xfrm>
            <a:off x="7623577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50°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11631E1-95A7-4897-8145-056537737AF8}"/>
              </a:ext>
            </a:extLst>
          </p:cNvPr>
          <p:cNvSpPr txBox="1"/>
          <p:nvPr/>
        </p:nvSpPr>
        <p:spPr>
          <a:xfrm>
            <a:off x="8568968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120°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B8673D3-533E-4D41-B69D-6EAC05DC513A}"/>
              </a:ext>
            </a:extLst>
          </p:cNvPr>
          <p:cNvSpPr txBox="1"/>
          <p:nvPr/>
        </p:nvSpPr>
        <p:spPr>
          <a:xfrm>
            <a:off x="9514359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90°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AC6BF07-F683-4602-9849-19121E1E9239}"/>
              </a:ext>
            </a:extLst>
          </p:cNvPr>
          <p:cNvSpPr txBox="1"/>
          <p:nvPr/>
        </p:nvSpPr>
        <p:spPr>
          <a:xfrm>
            <a:off x="1045975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60°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0DEABA0-83A9-470E-B18A-50BAB112ACA3}"/>
              </a:ext>
            </a:extLst>
          </p:cNvPr>
          <p:cNvSpPr txBox="1"/>
          <p:nvPr/>
        </p:nvSpPr>
        <p:spPr>
          <a:xfrm>
            <a:off x="11405143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-30°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02DBB82-28E2-464B-9D76-CCBA7B59F5DA}"/>
              </a:ext>
            </a:extLst>
          </p:cNvPr>
          <p:cNvSpPr txBox="1"/>
          <p:nvPr/>
        </p:nvSpPr>
        <p:spPr>
          <a:xfrm>
            <a:off x="1005840" y="-11707"/>
            <a:ext cx="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°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7008BCEB-C4AD-4020-9C80-77E42A892246}"/>
              </a:ext>
            </a:extLst>
          </p:cNvPr>
          <p:cNvCxnSpPr/>
          <p:nvPr/>
        </p:nvCxnSpPr>
        <p:spPr>
          <a:xfrm flipV="1">
            <a:off x="5977279" y="2541455"/>
            <a:ext cx="118721" cy="119286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4F3DBE33-81C6-4E29-A6FC-B74880202EDA}"/>
              </a:ext>
            </a:extLst>
          </p:cNvPr>
          <p:cNvSpPr txBox="1"/>
          <p:nvPr/>
        </p:nvSpPr>
        <p:spPr>
          <a:xfrm>
            <a:off x="5464967" y="2545325"/>
            <a:ext cx="556563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Gbl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862E32AC-9CC9-421A-9E8D-24F5735A3D73}"/>
              </a:ext>
            </a:extLst>
          </p:cNvPr>
          <p:cNvCxnSpPr/>
          <p:nvPr/>
        </p:nvCxnSpPr>
        <p:spPr>
          <a:xfrm flipV="1">
            <a:off x="2086022" y="4165722"/>
            <a:ext cx="170345" cy="138436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2">
            <a:extLst>
              <a:ext uri="{FF2B5EF4-FFF2-40B4-BE49-F238E27FC236}">
                <a16:creationId xmlns:a16="http://schemas.microsoft.com/office/drawing/2014/main" id="{2E353415-239A-427D-BDC1-410C9C75AE6B}"/>
              </a:ext>
            </a:extLst>
          </p:cNvPr>
          <p:cNvSpPr txBox="1"/>
          <p:nvPr/>
        </p:nvSpPr>
        <p:spPr>
          <a:xfrm>
            <a:off x="1550026" y="4180785"/>
            <a:ext cx="627095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Gbm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A802ED75-370D-47C4-819C-A170A2406FF0}"/>
              </a:ext>
            </a:extLst>
          </p:cNvPr>
          <p:cNvCxnSpPr/>
          <p:nvPr/>
        </p:nvCxnSpPr>
        <p:spPr>
          <a:xfrm flipH="1" flipV="1">
            <a:off x="6164122" y="4157766"/>
            <a:ext cx="74133" cy="138435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2">
            <a:extLst>
              <a:ext uri="{FF2B5EF4-FFF2-40B4-BE49-F238E27FC236}">
                <a16:creationId xmlns:a16="http://schemas.microsoft.com/office/drawing/2014/main" id="{837D46E4-83DC-4964-88DF-F4A7A71BB6D9}"/>
              </a:ext>
            </a:extLst>
          </p:cNvPr>
          <p:cNvSpPr txBox="1"/>
          <p:nvPr/>
        </p:nvSpPr>
        <p:spPr>
          <a:xfrm>
            <a:off x="6074655" y="4189735"/>
            <a:ext cx="377026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R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91A992BA-C2EA-445F-A575-2507520CA162}"/>
              </a:ext>
            </a:extLst>
          </p:cNvPr>
          <p:cNvCxnSpPr/>
          <p:nvPr/>
        </p:nvCxnSpPr>
        <p:spPr>
          <a:xfrm flipH="1">
            <a:off x="8887044" y="2921000"/>
            <a:ext cx="170596" cy="194352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2">
            <a:extLst>
              <a:ext uri="{FF2B5EF4-FFF2-40B4-BE49-F238E27FC236}">
                <a16:creationId xmlns:a16="http://schemas.microsoft.com/office/drawing/2014/main" id="{C47A6B51-FF0E-43B9-8272-E2F709797D30}"/>
              </a:ext>
            </a:extLst>
          </p:cNvPr>
          <p:cNvSpPr txBox="1"/>
          <p:nvPr/>
        </p:nvSpPr>
        <p:spPr>
          <a:xfrm>
            <a:off x="8875892" y="2760390"/>
            <a:ext cx="421910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F3DBE33-81C6-4E29-A6FC-B74880202EDA}"/>
              </a:ext>
            </a:extLst>
          </p:cNvPr>
          <p:cNvSpPr txBox="1"/>
          <p:nvPr/>
        </p:nvSpPr>
        <p:spPr>
          <a:xfrm>
            <a:off x="5454513" y="3363058"/>
            <a:ext cx="582211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i-FI" sz="9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Gce</a:t>
            </a:r>
            <a:endParaRPr lang="fi-FI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7008BCEB-C4AD-4020-9C80-77E42A892246}"/>
              </a:ext>
            </a:extLst>
          </p:cNvPr>
          <p:cNvCxnSpPr/>
          <p:nvPr/>
        </p:nvCxnSpPr>
        <p:spPr>
          <a:xfrm flipV="1">
            <a:off x="5957256" y="3308893"/>
            <a:ext cx="117399" cy="160228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56161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93</TotalTime>
  <Words>956</Words>
  <Application>Microsoft Office PowerPoint</Application>
  <PresentationFormat>Widescreen</PresentationFormat>
  <Paragraphs>364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dividual activation map montage U01</dc:title>
  <dc:creator>lauri lehto</dc:creator>
  <cp:lastModifiedBy>lauri lehto</cp:lastModifiedBy>
  <cp:revision>267</cp:revision>
  <dcterms:created xsi:type="dcterms:W3CDTF">2018-07-31T17:07:34Z</dcterms:created>
  <dcterms:modified xsi:type="dcterms:W3CDTF">2018-11-02T11:55:59Z</dcterms:modified>
</cp:coreProperties>
</file>